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2913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1494E-1CE2-42F1-B351-8AF20CD378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B5520C-C9ED-4DC0-83AF-1709F8A14A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2B07BE-09BC-49FB-8C55-200126C4FB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57ACA-A134-4AD6-AF01-BD31B69EF48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7109D7-A249-41C4-BF9F-54083A84F9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F53755-BB94-435A-B592-C3253FA079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2BF248-E3FD-4C6B-989A-A3DA9243C9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2587E-B0F8-4279-A52C-3745F008A8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A7AD48-CCB5-41A7-B1B9-4B527FC76B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D81BF0-3FD8-402D-BF51-B566367D27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2E7B3-D218-4EB9-9D5F-13FE462EBF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D12190-8408-47E8-BB2A-B045CE4C9E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526EBC-6ADA-4F6D-9E61-72706828F740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778"/>
          <p:cNvSpPr/>
          <p:nvPr/>
        </p:nvSpPr>
        <p:spPr>
          <a:xfrm>
            <a:off x="7277760" y="0"/>
            <a:ext cx="186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Table S4. Yun </a:t>
            </a:r>
            <a:r>
              <a:rPr b="0" i="1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et al</a:t>
            </a:r>
            <a:r>
              <a:rPr b="0" lang="en-US" sz="1400" spc="-1" strike="noStrike">
                <a:solidFill>
                  <a:srgbClr val="0000cc"/>
                </a:solidFill>
                <a:latin typeface="Arial Narrow"/>
                <a:ea typeface="Vrinda"/>
              </a:rPr>
              <a:t>., 2014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631800" y="450720"/>
          <a:ext cx="3889440" cy="6137280"/>
        </p:xfrm>
        <a:graphic>
          <a:graphicData uri="http://schemas.openxmlformats.org/drawingml/2006/table">
            <a:tbl>
              <a:tblPr/>
              <a:tblGrid>
                <a:gridCol w="793800"/>
                <a:gridCol w="2611440"/>
                <a:gridCol w="484200"/>
              </a:tblGrid>
              <a:tr h="30996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Oligonucleotid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             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quence</a:t>
                      </a:r>
                      <a:r>
                        <a:rPr b="1" i="1" lang="en-US" sz="1200" spc="-1" strike="noStrike" baseline="30000">
                          <a:solidFill>
                            <a:srgbClr val="000000"/>
                          </a:solidFill>
                          <a:latin typeface="Arial Narrow"/>
                        </a:rPr>
                        <a:t>a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Arial Narrow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(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5'→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  <a:ea typeface="Vrinda"/>
                        </a:rPr>
                        <a:t>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olar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1r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AGGGATCTGGGCGTTTCTGGCAA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1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atcccgggAGAAGTTTATCTGTGTGAAC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1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tgcggccgcCCACGTCGTTGTGCACGAAG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2r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TCTGCCTACTCTGCCCCTCCGTT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2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atcccgggTCAAGCTCAGTGATGTTAA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2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tgcggccgcGATGGGTTTCCGAGGATGAC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3r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CGGTCTTTCCTTCTGCTGCAGGT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3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atcccgggGAGGATACATTGCTACCAAG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3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tgcggccgcGTAAGTCAGTTCAATTATGG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4r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GATCCTGTGTTCTTCCTCACCAC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4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atcccgggAGTGGAAGGCTCAGGCGTCC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4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tgcggccgcAGATCCTGTGTTCTTCCTCA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sp6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ataccccgcgtattcccac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sp6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CAGATAAACTTCTctatagtgtccccta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FragI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ggggacactatagAGAAGTTTATCTGTG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FragI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GGATCATTGCCCATGGTAAGCT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X1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GAATGGATCGCACAGTGTGGAG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X1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AAGCTTCAAACTCAAGATACCGTGC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X2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GAGCACGGTATCTTGAGTTTGAAGCT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X2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acgtggacgagggcatgcctgc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RO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CAGGAGGACTGGGTTACCAAAG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RO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gggcggccgctctagAGATCCTGTGTTCTTCCTCACC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17-1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TCATTGCCACACTTTTTTCCACTGCT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17-2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AAGCAGTGGAAAAAAGTGTGGCAATG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419-1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GATTGAGCCTTCGTTTCCTCCTCTT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419-2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AAAGAGGAGGAAACGAAGGCTCAAT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708-1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CATTGGACGTCCGCATGATTAA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708-1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TGTGGCGTGCGCCTCTTCAAATTCCA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708-2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ATGGAATTTGAAGAGGCGCACGCCAC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1708-2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ATTTTTCGCGAACGAGAATTTT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BsrGI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TGGCTCTGAAAGGCACAACCTA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580-1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GGCGTTTCTGGCAGATATTTATACCT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2580-2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AGGTATAAATATCTGCCAGAAACGC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BamHI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CATGGATTGGGGCATTTGAGTC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215-1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TTGGTCCGGCTATAGTGTGCGGAATG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3215-2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CATTCCGCACACTATAGCCGGACCA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JSBamHI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TTTATGACAGCGACCCCGCCTG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5987-1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TTCTGCCTACTCTACCCCTCCGTTGA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4622760" y="450720"/>
          <a:ext cx="3889440" cy="6137280"/>
        </p:xfrm>
        <a:graphic>
          <a:graphicData uri="http://schemas.openxmlformats.org/drawingml/2006/table">
            <a:tbl>
              <a:tblPr/>
              <a:tblGrid>
                <a:gridCol w="793800"/>
                <a:gridCol w="2611440"/>
                <a:gridCol w="484200"/>
              </a:tblGrid>
              <a:tr h="30996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Oligonucleotid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                 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quence</a:t>
                      </a:r>
                      <a:r>
                        <a:rPr b="1" i="1" lang="en-US" sz="1200" spc="-1" strike="noStrike" baseline="30000">
                          <a:solidFill>
                            <a:srgbClr val="000000"/>
                          </a:solidFill>
                          <a:latin typeface="Arial Narrow"/>
                        </a:rPr>
                        <a:t>a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 Narrow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(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5'→3'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olarit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5987-2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CTCAACGGAGGGGTAGAGTAGGCAGA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5987-2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ACCTCGGTGTTGTCCTCCAGTA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6551-1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CAGCCGTTGCAACTAAGTACATGGTG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6551-2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ACACCATGTACTTAGTTGCAACGGCT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6551-2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ATAATGAGCCAGCTTGTGAGTT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588-1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AGTCCAGAAGTAGAAGAACAAC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588-1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CGTGGTATGTCCAGGTGCGGTATGGA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588-2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ATCCATACCGCACCTGGACATACCAC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8588-2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CTATTGCATCCTAGACGAGGCTT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GGAATTTGAAGACGCGCACGCCA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D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GTGGCGTGCGCGTCTTCAAATTC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GGAATTTGAAGCCGCGCACGCCA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GTGGCGTGCGCGGCTTCAAATTC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L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GGAATTTGAACTGGCGCACGCC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L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TGGCGTGCGCCAGTTCAAATTC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GGAATTTGAACCGGCGCACGCC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TGGCGTGCGCCGGTTCAAATTC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V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GGAATTTGAAGTCGCGCACGCCA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V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GTGGCGTGCGCGACTTCAAATTC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K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GGAATTTGAAAAGGCGCACGCC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K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TGGCGTGCGCCTTTTCAAATTC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R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GGAATTTGAAAGAGCGCACGCCA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R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GTGGCGTGCGCTCTTTCAAATTC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F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GGAATTTGAATTCGCGCACGCCA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F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GTGGCGTGCGCGAATTCAAATTC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W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GGAATTTGAATGGGCGCACGCC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W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TGGCGTGCGCCCATTCAAATTC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GGAATTTGAAAGCGCGCACGCCA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GTGGCGTGCGCGCTTTCAAATTC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GGAATTTGAAACGGCGCACGCC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TGGCGTGCGCCGTTTCAAATTC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N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GGAATTTGAAAACGCGCACGCCA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N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TGTGGCGTGCGCGTTTTCAAATTC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Q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GGAATTTGAACAGGCGCACGCC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Q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GTGGCGTGCGCCTGTTCAAATTCC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rMEr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TTATACCTATCCACCCAGGCTT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rMEf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atctcgagAGTTGTCATAGCTTGTGCA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57680"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prMEr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ttccgcggTGATGTCAATGGCACATCC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5040" rIns="5040" tIns="50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 Narrow"/>
                        </a:rPr>
                        <a:t>Antisen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5040" marR="50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44" name="Group 20"/>
          <p:cNvGrpSpPr/>
          <p:nvPr/>
        </p:nvGrpSpPr>
        <p:grpSpPr>
          <a:xfrm>
            <a:off x="4541760" y="468360"/>
            <a:ext cx="22320" cy="6099120"/>
            <a:chOff x="4541760" y="468360"/>
            <a:chExt cx="22320" cy="6099120"/>
          </a:xfrm>
        </p:grpSpPr>
        <p:grpSp>
          <p:nvGrpSpPr>
            <p:cNvPr id="45" name="Group 36"/>
            <p:cNvGrpSpPr/>
            <p:nvPr/>
          </p:nvGrpSpPr>
          <p:grpSpPr>
            <a:xfrm>
              <a:off x="4541760" y="648720"/>
              <a:ext cx="22320" cy="5918760"/>
              <a:chOff x="4541760" y="648720"/>
              <a:chExt cx="22320" cy="5918760"/>
            </a:xfrm>
          </p:grpSpPr>
          <p:sp>
            <p:nvSpPr>
              <p:cNvPr id="46" name="직선 연결선 29"/>
              <p:cNvSpPr/>
              <p:nvPr/>
            </p:nvSpPr>
            <p:spPr>
              <a:xfrm>
                <a:off x="4541760" y="648720"/>
                <a:ext cx="0" cy="5918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47" name="직선 연결선 30"/>
              <p:cNvSpPr/>
              <p:nvPr/>
            </p:nvSpPr>
            <p:spPr>
              <a:xfrm>
                <a:off x="4564080" y="648720"/>
                <a:ext cx="0" cy="5918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  <p:grpSp>
          <p:nvGrpSpPr>
            <p:cNvPr id="48" name="Group 36"/>
            <p:cNvGrpSpPr/>
            <p:nvPr/>
          </p:nvGrpSpPr>
          <p:grpSpPr>
            <a:xfrm>
              <a:off x="4541760" y="468360"/>
              <a:ext cx="22320" cy="126000"/>
              <a:chOff x="4541760" y="468360"/>
              <a:chExt cx="22320" cy="126000"/>
            </a:xfrm>
          </p:grpSpPr>
          <p:sp>
            <p:nvSpPr>
              <p:cNvPr id="49" name="직선 연결선 29"/>
              <p:cNvSpPr/>
              <p:nvPr/>
            </p:nvSpPr>
            <p:spPr>
              <a:xfrm>
                <a:off x="4541760" y="468360"/>
                <a:ext cx="0" cy="126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sp>
            <p:nvSpPr>
              <p:cNvPr id="50" name="직선 연결선 30"/>
              <p:cNvSpPr/>
              <p:nvPr/>
            </p:nvSpPr>
            <p:spPr>
              <a:xfrm>
                <a:off x="4564080" y="468360"/>
                <a:ext cx="0" cy="126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</p:grpSp>
      </p:grpSp>
      <p:grpSp>
        <p:nvGrpSpPr>
          <p:cNvPr id="51" name="Group 21"/>
          <p:cNvGrpSpPr/>
          <p:nvPr/>
        </p:nvGrpSpPr>
        <p:grpSpPr>
          <a:xfrm>
            <a:off x="612720" y="446040"/>
            <a:ext cx="7899480" cy="6153120"/>
            <a:chOff x="612720" y="446040"/>
            <a:chExt cx="7899480" cy="6153120"/>
          </a:xfrm>
        </p:grpSpPr>
        <p:sp>
          <p:nvSpPr>
            <p:cNvPr id="52" name="직선 연결선 15"/>
            <p:cNvSpPr/>
            <p:nvPr/>
          </p:nvSpPr>
          <p:spPr>
            <a:xfrm>
              <a:off x="612720" y="446040"/>
              <a:ext cx="78994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3" name="직선 연결선 16"/>
            <p:cNvSpPr/>
            <p:nvPr/>
          </p:nvSpPr>
          <p:spPr>
            <a:xfrm>
              <a:off x="612720" y="618840"/>
              <a:ext cx="7899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4" name="직선 연결선 15"/>
            <p:cNvSpPr/>
            <p:nvPr/>
          </p:nvSpPr>
          <p:spPr>
            <a:xfrm>
              <a:off x="612720" y="6599160"/>
              <a:ext cx="78994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55" name="Rectangle 3"/>
          <p:cNvSpPr/>
          <p:nvPr/>
        </p:nvSpPr>
        <p:spPr>
          <a:xfrm>
            <a:off x="525600" y="190440"/>
            <a:ext cx="6700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4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ligonucleotides used for ligation, cDNA synthesis, and PCR amplification.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6" name="Rectangle 4"/>
          <p:cNvSpPr/>
          <p:nvPr/>
        </p:nvSpPr>
        <p:spPr>
          <a:xfrm>
            <a:off x="550800" y="6568920"/>
            <a:ext cx="280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 baseline="30000">
                <a:solidFill>
                  <a:srgbClr val="000000"/>
                </a:solidFill>
                <a:latin typeface="Arial Narrow"/>
                <a:ea typeface="Times New Roman"/>
              </a:rPr>
              <a:t>a </a:t>
            </a:r>
            <a:r>
              <a:rPr b="0" lang="en-US" sz="1000" spc="-1" strike="noStrike">
                <a:solidFill>
                  <a:srgbClr val="000000"/>
                </a:solidFill>
                <a:latin typeface="Arial Narrow"/>
                <a:ea typeface="Times New Roman"/>
              </a:rPr>
              <a:t>JEV-specific sequences are shown in capital letters.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7-05T16:33:49Z</dcterms:created>
  <dc:creator>Youngmin Lee</dc:creator>
  <dc:description/>
  <dc:language>en-US</dc:language>
  <cp:lastModifiedBy>Young-Min Lee</cp:lastModifiedBy>
  <cp:lastPrinted>2013-06-05T03:05:47Z</cp:lastPrinted>
  <dcterms:modified xsi:type="dcterms:W3CDTF">2014-01-30T00:31:23Z</dcterms:modified>
  <cp:revision>265</cp:revision>
  <dc:subject/>
  <dc:title>PowerPoint 프레젠테이션</dc:title>
</cp:coreProperties>
</file>